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changesInfos/changesInfo1.xml" ContentType="application/vnd.ms-powerpoint.changesinfo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9" r:id="rId3"/>
    <p:sldId id="257" r:id="rId4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25" autoAdjust="0"/>
    <p:restoredTop sz="84000" autoAdjust="0"/>
  </p:normalViewPr>
  <p:slideViewPr>
    <p:cSldViewPr snapToGrid="0" showGuides="1">
      <p:cViewPr varScale="1">
        <p:scale>
          <a:sx n="61" d="100"/>
          <a:sy n="61" d="100"/>
        </p:scale>
        <p:origin x="-978" y="-7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iam Grgic" userId="S::mgr011@uit.no::66f5ed7f-62c1-4d91-a089-42a0bc1b11a5" providerId="AD" clId="Web-{5D421F6B-28DA-7061-5E74-09DE46BF25BF}"/>
    <pc:docChg chg="addSld modSld">
      <pc:chgData name="Miriam Grgic" userId="S::mgr011@uit.no::66f5ed7f-62c1-4d91-a089-42a0bc1b11a5" providerId="AD" clId="Web-{5D421F6B-28DA-7061-5E74-09DE46BF25BF}" dt="2019-01-21T11:37:22.293" v="17" actId="1076"/>
      <pc:docMkLst>
        <pc:docMk/>
      </pc:docMkLst>
      <pc:sldChg chg="addSp delSp modSp">
        <pc:chgData name="Miriam Grgic" userId="S::mgr011@uit.no::66f5ed7f-62c1-4d91-a089-42a0bc1b11a5" providerId="AD" clId="Web-{5D421F6B-28DA-7061-5E74-09DE46BF25BF}" dt="2019-01-21T11:37:13.949" v="16" actId="1076"/>
        <pc:sldMkLst>
          <pc:docMk/>
          <pc:sldMk cId="3110005270" sldId="257"/>
        </pc:sldMkLst>
        <pc:spChg chg="add del mod">
          <ac:chgData name="Miriam Grgic" userId="S::mgr011@uit.no::66f5ed7f-62c1-4d91-a089-42a0bc1b11a5" providerId="AD" clId="Web-{5D421F6B-28DA-7061-5E74-09DE46BF25BF}" dt="2019-01-21T11:36:37.043" v="10"/>
          <ac:spMkLst>
            <pc:docMk/>
            <pc:sldMk cId="3110005270" sldId="257"/>
            <ac:spMk id="4" creationId="{3F16DDD1-2F4D-4619-BC81-58CF65BDA99C}"/>
          </ac:spMkLst>
        </pc:spChg>
        <pc:spChg chg="mod">
          <ac:chgData name="Miriam Grgic" userId="S::mgr011@uit.no::66f5ed7f-62c1-4d91-a089-42a0bc1b11a5" providerId="AD" clId="Web-{5D421F6B-28DA-7061-5E74-09DE46BF25BF}" dt="2019-01-21T11:37:13.949" v="16" actId="1076"/>
          <ac:spMkLst>
            <pc:docMk/>
            <pc:sldMk cId="3110005270" sldId="257"/>
            <ac:spMk id="6" creationId="{00000000-0000-0000-0000-000000000000}"/>
          </ac:spMkLst>
        </pc:spChg>
        <pc:graphicFrameChg chg="add mod modGraphic">
          <ac:chgData name="Miriam Grgic" userId="S::mgr011@uit.no::66f5ed7f-62c1-4d91-a089-42a0bc1b11a5" providerId="AD" clId="Web-{5D421F6B-28DA-7061-5E74-09DE46BF25BF}" dt="2019-01-21T11:37:04.293" v="15" actId="1076"/>
          <ac:graphicFrameMkLst>
            <pc:docMk/>
            <pc:sldMk cId="3110005270" sldId="257"/>
            <ac:graphicFrameMk id="3" creationId="{2B1805B1-F3BC-4775-AD02-F0BD8A7C461B}"/>
          </ac:graphicFrameMkLst>
        </pc:graphicFrameChg>
      </pc:sldChg>
      <pc:sldChg chg="addSp modSp new">
        <pc:chgData name="Miriam Grgic" userId="S::mgr011@uit.no::66f5ed7f-62c1-4d91-a089-42a0bc1b11a5" providerId="AD" clId="Web-{5D421F6B-28DA-7061-5E74-09DE46BF25BF}" dt="2019-01-21T11:37:22.293" v="17" actId="1076"/>
        <pc:sldMkLst>
          <pc:docMk/>
          <pc:sldMk cId="4278019164" sldId="260"/>
        </pc:sldMkLst>
        <pc:spChg chg="add mod">
          <ac:chgData name="Miriam Grgic" userId="S::mgr011@uit.no::66f5ed7f-62c1-4d91-a089-42a0bc1b11a5" providerId="AD" clId="Web-{5D421F6B-28DA-7061-5E74-09DE46BF25BF}" dt="2019-01-21T11:37:22.293" v="17" actId="1076"/>
          <ac:spMkLst>
            <pc:docMk/>
            <pc:sldMk cId="4278019164" sldId="260"/>
            <ac:spMk id="2" creationId="{FAE66DE7-3908-406E-A1AF-03E3871A5459}"/>
          </ac:spMkLst>
        </pc:spChg>
      </pc:sldChg>
    </pc:docChg>
  </pc:docChgLst>
  <pc:docChgLst>
    <pc:chgData name="Miriam Grgic" userId="S::mgr011@uit.no::66f5ed7f-62c1-4d91-a089-42a0bc1b11a5" providerId="AD" clId="Web-{A8F0BC48-6957-9578-9D7D-4A6E9932A271}"/>
    <pc:docChg chg="addSld delSld modSld">
      <pc:chgData name="Miriam Grgic" userId="S::mgr011@uit.no::66f5ed7f-62c1-4d91-a089-42a0bc1b11a5" providerId="AD" clId="Web-{A8F0BC48-6957-9578-9D7D-4A6E9932A271}" dt="2019-07-02T11:42:00.461" v="137"/>
      <pc:docMkLst>
        <pc:docMk/>
      </pc:docMkLst>
      <pc:sldChg chg="modSp">
        <pc:chgData name="Miriam Grgic" userId="S::mgr011@uit.no::66f5ed7f-62c1-4d91-a089-42a0bc1b11a5" providerId="AD" clId="Web-{A8F0BC48-6957-9578-9D7D-4A6E9932A271}" dt="2019-07-02T11:41:57.507" v="136" actId="1076"/>
        <pc:sldMkLst>
          <pc:docMk/>
          <pc:sldMk cId="2176814199" sldId="259"/>
        </pc:sldMkLst>
        <pc:spChg chg="mod">
          <ac:chgData name="Miriam Grgic" userId="S::mgr011@uit.no::66f5ed7f-62c1-4d91-a089-42a0bc1b11a5" providerId="AD" clId="Web-{A8F0BC48-6957-9578-9D7D-4A6E9932A271}" dt="2019-07-02T11:41:57.507" v="136" actId="1076"/>
          <ac:spMkLst>
            <pc:docMk/>
            <pc:sldMk cId="2176814199" sldId="259"/>
            <ac:spMk id="6" creationId="{00000000-0000-0000-0000-000000000000}"/>
          </ac:spMkLst>
        </pc:spChg>
        <pc:graphicFrameChg chg="mod modGraphic">
          <ac:chgData name="Miriam Grgic" userId="S::mgr011@uit.no::66f5ed7f-62c1-4d91-a089-42a0bc1b11a5" providerId="AD" clId="Web-{A8F0BC48-6957-9578-9D7D-4A6E9932A271}" dt="2019-07-02T11:41:52.726" v="134"/>
          <ac:graphicFrameMkLst>
            <pc:docMk/>
            <pc:sldMk cId="2176814199" sldId="259"/>
            <ac:graphicFrameMk id="2" creationId="{00000000-0000-0000-0000-000000000000}"/>
          </ac:graphicFrameMkLst>
        </pc:graphicFrameChg>
      </pc:sldChg>
      <pc:sldChg chg="addSp delSp modSp new del">
        <pc:chgData name="Miriam Grgic" userId="S::mgr011@uit.no::66f5ed7f-62c1-4d91-a089-42a0bc1b11a5" providerId="AD" clId="Web-{A8F0BC48-6957-9578-9D7D-4A6E9932A271}" dt="2019-07-02T11:42:00.461" v="137"/>
        <pc:sldMkLst>
          <pc:docMk/>
          <pc:sldMk cId="2692018173" sldId="260"/>
        </pc:sldMkLst>
        <pc:spChg chg="add del mod">
          <ac:chgData name="Miriam Grgic" userId="S::mgr011@uit.no::66f5ed7f-62c1-4d91-a089-42a0bc1b11a5" providerId="AD" clId="Web-{A8F0BC48-6957-9578-9D7D-4A6E9932A271}" dt="2019-07-02T11:29:24.118" v="6"/>
          <ac:spMkLst>
            <pc:docMk/>
            <pc:sldMk cId="2692018173" sldId="260"/>
            <ac:spMk id="4" creationId="{D99E6CA3-3ED8-4546-8788-818CFCCF0EF1}"/>
          </ac:spMkLst>
        </pc:spChg>
        <pc:graphicFrameChg chg="add mod modGraphic">
          <ac:chgData name="Miriam Grgic" userId="S::mgr011@uit.no::66f5ed7f-62c1-4d91-a089-42a0bc1b11a5" providerId="AD" clId="Web-{A8F0BC48-6957-9578-9D7D-4A6E9932A271}" dt="2019-07-02T11:40:09.367" v="104"/>
          <ac:graphicFrameMkLst>
            <pc:docMk/>
            <pc:sldMk cId="2692018173" sldId="260"/>
            <ac:graphicFrameMk id="3" creationId="{55D9EA05-F726-4DCF-B5E8-F2F5CEFD633D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47CDB6-FA57-4EA0-8514-E72D95AE63D7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nb-NO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A90EB33-9F0C-42A2-9FE3-A02D5566A270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26485989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885825" algn="l"/>
              </a:tabLst>
            </a:pPr>
            <a:r>
              <a:rPr kumimoji="0" lang="en-US" altLang="nb-NO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. </a:t>
            </a:r>
            <a:r>
              <a:rPr kumimoji="0" lang="en-US" altLang="nb-NO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ligonucleotides used</a:t>
            </a:r>
            <a:r>
              <a:rPr kumimoji="0" lang="en-US" altLang="nb-NO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r>
              <a:rPr kumimoji="0" lang="en-US" altLang="nb-NO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 this study</a:t>
            </a:r>
            <a:endParaRPr kumimoji="0" lang="nb-NO" altLang="nb-NO" sz="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90EB33-9F0C-42A2-9FE3-A02D5566A270}" type="slidenum">
              <a:rPr lang="nb-NO" smtClean="0"/>
              <a:pPr/>
              <a:t>2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92364112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ble S2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lasmids used in this study</a:t>
            </a:r>
            <a:endParaRPr lang="nb-NO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nb-NO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A90EB33-9F0C-42A2-9FE3-A02D5566A270}" type="slidenum">
              <a:rPr lang="nb-NO" smtClean="0"/>
              <a:pPr/>
              <a:t>3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28886602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26422766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1463319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25293112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796777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4093881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1450855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14772873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10042200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576139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8896879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998447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F1CEC0-2568-475B-A9B8-4A1773B2FA51}" type="datetimeFigureOut">
              <a:rPr lang="nb-NO" smtClean="0"/>
              <a:pPr/>
              <a:t>02.11.2019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E72ACC-6BBD-467E-9D7F-F4A029BDFCDB}" type="slidenum">
              <a:rPr lang="nb-NO" smtClean="0"/>
              <a:pPr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xmlns="" val="16279323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peik.haugen@uit.no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097902" y="542349"/>
            <a:ext cx="9538996" cy="25109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i="1" kern="1400" spc="-50" dirty="0">
                <a:latin typeface="Times New Roman" panose="02020603050405020304" pitchFamily="18" charset="0"/>
                <a:ea typeface="MS Gothic" panose="020B0609070205080204" pitchFamily="49" charset="-128"/>
                <a:cs typeface="Times New Roman" panose="02020603050405020304" pitchFamily="18" charset="0"/>
              </a:rPr>
              <a:t>Aliivibrio wodanis</a:t>
            </a:r>
            <a:r>
              <a:rPr lang="en-US" kern="1400" spc="-50" dirty="0">
                <a:latin typeface="Times New Roman" panose="02020603050405020304" pitchFamily="18" charset="0"/>
                <a:ea typeface="MS Gothic" panose="020B0609070205080204" pitchFamily="49" charset="-128"/>
                <a:cs typeface="Times New Roman" panose="02020603050405020304" pitchFamily="18" charset="0"/>
              </a:rPr>
              <a:t> </a:t>
            </a:r>
            <a:r>
              <a:rPr lang="en-US" kern="1400" spc="-50" dirty="0" smtClean="0">
                <a:latin typeface="Times New Roman" panose="02020603050405020304" pitchFamily="18" charset="0"/>
                <a:ea typeface="MS Gothic" panose="020B0609070205080204" pitchFamily="49" charset="-128"/>
                <a:cs typeface="Times New Roman" panose="02020603050405020304" pitchFamily="18" charset="0"/>
              </a:rPr>
              <a:t>as a </a:t>
            </a:r>
            <a:r>
              <a:rPr lang="en-US" kern="1400" spc="-50" dirty="0">
                <a:latin typeface="Times New Roman" panose="02020603050405020304" pitchFamily="18" charset="0"/>
                <a:ea typeface="MS Gothic" panose="020B0609070205080204" pitchFamily="49" charset="-128"/>
                <a:cs typeface="Times New Roman" panose="02020603050405020304" pitchFamily="18" charset="0"/>
              </a:rPr>
              <a:t>production host: development of genetic tools </a:t>
            </a:r>
            <a:r>
              <a:rPr lang="en-US" kern="1400" spc="-50" dirty="0" smtClean="0">
                <a:latin typeface="Times New Roman" panose="02020603050405020304" pitchFamily="18" charset="0"/>
                <a:ea typeface="MS Gothic" panose="020B0609070205080204" pitchFamily="49" charset="-128"/>
                <a:cs typeface="Times New Roman" panose="02020603050405020304" pitchFamily="18" charset="0"/>
              </a:rPr>
              <a:t>for expression </a:t>
            </a:r>
            <a:r>
              <a:rPr lang="en-US" kern="1400" spc="-50" dirty="0">
                <a:latin typeface="Times New Roman" panose="02020603050405020304" pitchFamily="18" charset="0"/>
                <a:ea typeface="MS Gothic" panose="020B0609070205080204" pitchFamily="49" charset="-128"/>
                <a:cs typeface="Times New Roman" panose="02020603050405020304" pitchFamily="18" charset="0"/>
              </a:rPr>
              <a:t>of cold-active enzymes </a:t>
            </a:r>
            <a:endParaRPr lang="nb-NO" sz="2800" kern="1400" spc="-50" dirty="0">
              <a:effectLst/>
              <a:latin typeface="Calibri Light" panose="020F0302020204030204" pitchFamily="34" charset="0"/>
              <a:ea typeface="MS Gothic" panose="020B0609070205080204" pitchFamily="49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nb-NO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nb-NO" sz="1200" dirty="0">
                <a:effectLst/>
                <a:latin typeface="Times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enny Johansson Söderberg</a:t>
            </a:r>
            <a:r>
              <a:rPr lang="nb-NO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†</a:t>
            </a:r>
            <a:r>
              <a:rPr lang="nb-NO" sz="1200" dirty="0">
                <a:effectLst/>
                <a:latin typeface="Times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iriam Grgic</a:t>
            </a:r>
            <a:r>
              <a:rPr lang="nb-NO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†</a:t>
            </a:r>
            <a:r>
              <a:rPr lang="nb-NO" sz="1200" dirty="0">
                <a:effectLst/>
                <a:latin typeface="Times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Erik Hjerde and Peik Haugen*</a:t>
            </a: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nb-NO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† </a:t>
            </a:r>
            <a:r>
              <a:rPr lang="nb-NO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ntributed</a:t>
            </a:r>
            <a:r>
              <a:rPr lang="nb-NO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b-NO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qually</a:t>
            </a:r>
            <a:r>
              <a:rPr lang="nb-NO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 , * </a:t>
            </a:r>
            <a:r>
              <a:rPr lang="nb-NO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ing</a:t>
            </a:r>
            <a:r>
              <a:rPr lang="nb-NO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b-NO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uthor</a:t>
            </a:r>
            <a:r>
              <a:rPr lang="nb-NO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nb-NO" sz="11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peik.haugen@uit.no</a:t>
            </a:r>
            <a:endParaRPr lang="nb-NO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of Chemistry and Center for Bioinformatics (</a:t>
            </a:r>
            <a:r>
              <a:rPr lang="en-US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fB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The Norwegian Structural Biology Centre (</a:t>
            </a:r>
            <a:r>
              <a:rPr lang="en-US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rStruct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, Faculty of Science and Technology, </a:t>
            </a:r>
            <a:r>
              <a:rPr lang="en-US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iT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 − The Arctic University of Norway, 9037 </a:t>
            </a:r>
            <a:r>
              <a:rPr lang="en-US" sz="11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romsø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Norway</a:t>
            </a:r>
            <a:endParaRPr lang="nb-NO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endParaRPr lang="nb-NO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0" y="3429000"/>
            <a:ext cx="1219199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2800" dirty="0" err="1"/>
              <a:t>Additional</a:t>
            </a:r>
            <a:r>
              <a:rPr lang="nb-NO" sz="2800" dirty="0"/>
              <a:t> file 2</a:t>
            </a:r>
          </a:p>
          <a:p>
            <a:pPr algn="ctr"/>
            <a:endParaRPr lang="nb-NO" sz="2800" dirty="0"/>
          </a:p>
          <a:p>
            <a:pPr algn="ctr"/>
            <a:r>
              <a:rPr lang="nb-NO" sz="2800" dirty="0"/>
              <a:t>(</a:t>
            </a:r>
            <a:r>
              <a:rPr lang="nb-NO" sz="2800" dirty="0" err="1"/>
              <a:t>Contains</a:t>
            </a:r>
            <a:r>
              <a:rPr lang="nb-NO" sz="2800" dirty="0"/>
              <a:t> </a:t>
            </a:r>
            <a:r>
              <a:rPr lang="nb-NO" sz="2800" dirty="0" err="1"/>
              <a:t>Supplementary</a:t>
            </a:r>
            <a:r>
              <a:rPr lang="nb-NO" sz="2800" dirty="0"/>
              <a:t> </a:t>
            </a:r>
            <a:r>
              <a:rPr lang="nb-NO" sz="2800" dirty="0" err="1"/>
              <a:t>tables</a:t>
            </a:r>
            <a:r>
              <a:rPr lang="nb-NO" sz="2800" dirty="0"/>
              <a:t> S1-S2)</a:t>
            </a:r>
          </a:p>
        </p:txBody>
      </p:sp>
    </p:spTree>
    <p:extLst>
      <p:ext uri="{BB962C8B-B14F-4D97-AF65-F5344CB8AC3E}">
        <p14:creationId xmlns:p14="http://schemas.microsoft.com/office/powerpoint/2010/main" xmlns="" val="42089399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78420" y="189571"/>
            <a:ext cx="955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smtClean="0"/>
              <a:t>Table </a:t>
            </a:r>
            <a:r>
              <a:rPr lang="nb-NO" dirty="0"/>
              <a:t>S1</a:t>
            </a:r>
          </a:p>
        </p:txBody>
      </p:sp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3054588" y="6461624"/>
            <a:ext cx="1740733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885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885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885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885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885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885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885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885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8858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885825" algn="l"/>
              </a:tabLst>
            </a:pPr>
            <a:r>
              <a:rPr kumimoji="0" lang="nb-NO" altLang="nb-NO" sz="12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kumimoji="0" lang="nb-NO" altLang="nb-NO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nb-NO" altLang="nb-NO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ligonuclotide</a:t>
            </a:r>
            <a:r>
              <a:rPr kumimoji="0" lang="nb-NO" altLang="nb-NO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nb-NO" altLang="nb-NO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umber</a:t>
            </a:r>
            <a:r>
              <a:rPr kumimoji="0" lang="nb-NO" altLang="nb-NO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kumimoji="0" lang="nb-NO" altLang="nb-NO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1509186294"/>
              </p:ext>
            </p:extLst>
          </p:nvPr>
        </p:nvGraphicFramePr>
        <p:xfrm>
          <a:off x="3119303" y="247474"/>
          <a:ext cx="6463906" cy="617262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95749">
                  <a:extLst>
                    <a:ext uri="{9D8B030D-6E8A-4147-A177-3AD203B41FA5}">
                      <a16:colId xmlns:a16="http://schemas.microsoft.com/office/drawing/2014/main" xmlns="" val="2860391163"/>
                    </a:ext>
                  </a:extLst>
                </a:gridCol>
                <a:gridCol w="1682342">
                  <a:extLst>
                    <a:ext uri="{9D8B030D-6E8A-4147-A177-3AD203B41FA5}">
                      <a16:colId xmlns:a16="http://schemas.microsoft.com/office/drawing/2014/main" xmlns="" val="3174220831"/>
                    </a:ext>
                  </a:extLst>
                </a:gridCol>
                <a:gridCol w="4385815">
                  <a:extLst>
                    <a:ext uri="{9D8B030D-6E8A-4147-A177-3AD203B41FA5}">
                      <a16:colId xmlns:a16="http://schemas.microsoft.com/office/drawing/2014/main" xmlns="" val="463125581"/>
                    </a:ext>
                  </a:extLst>
                </a:gridCol>
              </a:tblGrid>
              <a:tr h="2015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No.</a:t>
                      </a:r>
                      <a:r>
                        <a:rPr lang="nb-NO" sz="1000" baseline="30000" dirty="0">
                          <a:effectLst/>
                        </a:rPr>
                        <a:t>1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 err="1">
                          <a:effectLst/>
                        </a:rPr>
                        <a:t>Name</a:t>
                      </a:r>
                      <a:endParaRPr lang="nb-NO" sz="1000" dirty="0" err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 err="1">
                          <a:effectLst/>
                        </a:rPr>
                        <a:t>Sequence</a:t>
                      </a:r>
                      <a:r>
                        <a:rPr lang="nb-NO" sz="1000" dirty="0">
                          <a:effectLst/>
                        </a:rPr>
                        <a:t> (5'-3')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1149362740"/>
                  </a:ext>
                </a:extLst>
              </a:tr>
              <a:tr h="2015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1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pTM214_2R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GTCGACCTGCAGGCATGC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4208331906"/>
                  </a:ext>
                </a:extLst>
              </a:tr>
              <a:tr h="2015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2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pTM214_2F 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GGTGAAGGGATCAATTCCCT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2315948938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3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pTM214_1F 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CATGCTTAATTTCTCCTCTTTAATTAGATCC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3232432423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4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A.s_exoI_F</a:t>
                      </a:r>
                      <a:endParaRPr lang="nb-NO" sz="1000" dirty="0" err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GGAGAAATTAAGCATGATGCATCATCACCATCACCATGGT 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124430751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5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A.s_exoI</a:t>
                      </a:r>
                      <a:r>
                        <a:rPr lang="en-US" sz="1000" dirty="0">
                          <a:effectLst/>
                        </a:rPr>
                        <a:t>_ R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TGCCTGCAGGTCGACTCATGATACTAACTGTTGTACGTA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3646212038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6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A.s_polII_F</a:t>
                      </a:r>
                      <a:endParaRPr lang="nb-NO" sz="1000" dirty="0" err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GGAGAAATTAAGCATGATGCATCATCACCATCACCATGGT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1012338709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7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A.s_polII</a:t>
                      </a:r>
                      <a:r>
                        <a:rPr lang="en-US" sz="1000" dirty="0">
                          <a:effectLst/>
                        </a:rPr>
                        <a:t>_ R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ATGCCTGCAGGTCGACTTAGAATAGACCTAATTGAGAAGC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1401286868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8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GFP_F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AATTGATCCCTTCACCATGGGCAAAGTGAGCAAGGGCGAG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670653703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9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GFP_R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ATGCCTGCAGGTCGACCTTGTACAGCTCGTCCATGCCGAG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716860558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10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v_pTM214_changeP_F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GATCTCTGCAGTACCTGTGA 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2267868592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11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v_pTM214_changeP_R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ATGCATCATCACCATCACCATG  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234835652"/>
                  </a:ext>
                </a:extLst>
              </a:tr>
              <a:tr h="18030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12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i_174p_F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AGGTACTGCAGAGATCTTTACTGATAAAATGGTCATTTAT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487316623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13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i_</a:t>
                      </a:r>
                      <a:r>
                        <a:rPr lang="nb-NO" sz="1000" b="0" i="0" u="none" strike="noStrike" noProof="0" dirty="0">
                          <a:effectLst/>
                          <a:latin typeface="Calibri"/>
                        </a:rPr>
                        <a:t>174</a:t>
                      </a:r>
                      <a:r>
                        <a:rPr lang="nb-NO" sz="1000" dirty="0">
                          <a:effectLst/>
                        </a:rPr>
                        <a:t>p_R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GATGGTGATGATGCATTATTTTTATCTCCAAATATATATT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128807875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14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V_5_</a:t>
                      </a:r>
                      <a:r>
                        <a:rPr lang="nb-NO" sz="1000" b="0" i="0" u="none" strike="noStrike" noProof="0" dirty="0">
                          <a:effectLst/>
                          <a:latin typeface="Calibri"/>
                        </a:rPr>
                        <a:t>174</a:t>
                      </a:r>
                      <a:r>
                        <a:rPr lang="en-US" sz="1000" dirty="0">
                          <a:effectLst/>
                        </a:rPr>
                        <a:t>_F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GCTGCTGGAAGAAGTcCAAACTTCATTTGCTTACTCATGCTTAATTTCTCCTCTTTAAT</a:t>
                      </a:r>
                      <a:endParaRPr lang="nb-NO" sz="1000" dirty="0" err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1413882916"/>
                  </a:ext>
                </a:extLst>
              </a:tr>
              <a:tr h="32878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15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V_5_</a:t>
                      </a:r>
                      <a:r>
                        <a:rPr lang="nb-NO" sz="1000" b="0" i="0" u="none" strike="noStrike" noProof="0" dirty="0">
                          <a:effectLst/>
                          <a:latin typeface="Calibri"/>
                        </a:rPr>
                        <a:t>174</a:t>
                      </a:r>
                      <a:r>
                        <a:rPr lang="en-US" sz="1000" dirty="0">
                          <a:effectLst/>
                        </a:rPr>
                        <a:t>_R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GACTTCTTCCAGCAGCGATCGCTGGTGCATTACTGAGCTTTCAGGGAATTGATCCCTTCACC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3113147264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16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His_tag_F</a:t>
                      </a:r>
                      <a:endParaRPr lang="nb-NO" sz="1000" dirty="0" err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ATGGTGATGGTGATGATGCTTGTACAGCTCGTCCATGCC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1766830626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17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His_tag_R</a:t>
                      </a:r>
                      <a:endParaRPr lang="nb-NO" sz="1000" dirty="0" err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CATCATCACCATCACCATTAACGACCTGCAGGCATGCAAGCTT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2994723519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18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v_5his_F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GCTCAGTAATGCACCAGCGATCGC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3994335205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19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v_5his_R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CATCATCACCATCACCATTAAGTC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2334404703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20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i_5his_L6_F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TGGTGCATTACTGAGCCAGCAGACCACCCAGAAAACACAG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2143868655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21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i_5his_L6_R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GGTGATGGTGATGATGTTAGCCGCTTGCTTTAATACGCCA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2366969105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22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i_5his_strepADH_F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TGGTGCATTACTGAGCGGTCGTGCAGTTGTGTTTGAAGAA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4131319870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23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i_5his_strepADH_R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GGTGATGGTGATGATGTGCACCATCAGGATGCGGACGACG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872333411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24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i_5his_MvExo_F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TGGTGCATTACTGAGCGATAACAATTCGAACAAAACAGCA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3858265181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25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i_5his_MvExo_R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GGTGATGGTGATGATGTGCGCCAATTATTTTTTGACCATA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104898271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26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i_5his_Halo_F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TGGTGCATTACTGAGCGGTGATAGCACCATGCGTGCAGCA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2500650167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27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i_5his_Halo_R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GGTGATGGTGATGATGGGCCATATCCAGAACAATACGACC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685821570"/>
                  </a:ext>
                </a:extLst>
              </a:tr>
              <a:tr h="16969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28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i_5his_L1_F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TGGTGCATTACTGAGCCAGTTTAGCGTTCTGGCAGGTAGC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1521498955"/>
                  </a:ext>
                </a:extLst>
              </a:tr>
              <a:tr h="986349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29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30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31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32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33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O34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i_5his_L1_R</a:t>
                      </a:r>
                    </a:p>
                    <a:p>
                      <a:pPr lvl="0">
                        <a:lnSpc>
                          <a:spcPct val="107000"/>
                        </a:lnSpc>
                        <a:spcAft>
                          <a:spcPts val="0"/>
                        </a:spcAft>
                        <a:buNone/>
                      </a:pPr>
                      <a:r>
                        <a:rPr lang="nb-NO" sz="1000" b="0" i="0" u="none" strike="noStrike" noProof="0" dirty="0">
                          <a:effectLst/>
                          <a:latin typeface="Calibri"/>
                        </a:rPr>
                        <a:t>174</a:t>
                      </a:r>
                      <a:r>
                        <a:rPr lang="nb-NO" sz="1000" dirty="0">
                          <a:effectLst/>
                        </a:rPr>
                        <a:t>F</a:t>
                      </a:r>
                      <a:endParaRPr lang="nb-NO" dirty="0"/>
                    </a:p>
                    <a:p>
                      <a:pPr lvl="0">
                        <a:lnSpc>
                          <a:spcPct val="107000"/>
                        </a:lnSpc>
                        <a:spcAft>
                          <a:spcPts val="0"/>
                        </a:spcAft>
                        <a:buNone/>
                      </a:pPr>
                      <a:r>
                        <a:rPr lang="nb-NO" sz="1000" b="0" i="0" u="none" strike="noStrike" noProof="0" dirty="0">
                          <a:effectLst/>
                          <a:latin typeface="Calibri"/>
                        </a:rPr>
                        <a:t>174</a:t>
                      </a:r>
                      <a:r>
                        <a:rPr lang="nb-NO" sz="1000" dirty="0">
                          <a:effectLst/>
                        </a:rPr>
                        <a:t>R_tag</a:t>
                      </a:r>
                      <a:endParaRPr lang="nb-NO" dirty="0"/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V_TEV_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pTM214_R_tags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 err="1">
                          <a:effectLst/>
                        </a:rPr>
                        <a:t>V_ctermHis_F</a:t>
                      </a:r>
                      <a:endParaRPr lang="nb-NO" sz="1000" dirty="0" err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GGTGATGGTGATGATGAACACCAGGCTGACCATCCGGCAC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GGAGAAATTAAGCATGAGTAAGCAAATGAAGTTTGGA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GAAAATACAGGTTTTCTGTACCAGCGAATGCGTTGCCGC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GAAAACCTGTATTTTCAGGGAAT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ATTAAAGAGGAGAAATTAAGCATG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nb-NO" sz="1000" dirty="0">
                          <a:effectLst/>
                        </a:rPr>
                        <a:t>GACTTAATGGTGATGGTGATGATG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8629" marR="58629" marT="0" marB="0"/>
                </a:tc>
                <a:extLst>
                  <a:ext uri="{0D108BD9-81ED-4DB2-BD59-A6C34878D82A}">
                    <a16:rowId xmlns:a16="http://schemas.microsoft.com/office/drawing/2014/main" xmlns="" val="402486751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21768141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6500" y="47331"/>
            <a:ext cx="955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mtClean="0"/>
              <a:t>Table </a:t>
            </a:r>
            <a:r>
              <a:rPr lang="nb-NO" dirty="0"/>
              <a:t>S2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xmlns="" id="{2B1805B1-F3BC-4775-AD02-F0BD8A7C46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096065865"/>
              </p:ext>
            </p:extLst>
          </p:nvPr>
        </p:nvGraphicFramePr>
        <p:xfrm>
          <a:off x="2494027" y="123371"/>
          <a:ext cx="9138615" cy="575284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48044">
                  <a:extLst>
                    <a:ext uri="{9D8B030D-6E8A-4147-A177-3AD203B41FA5}">
                      <a16:colId xmlns:a16="http://schemas.microsoft.com/office/drawing/2014/main" xmlns="" val="3612143144"/>
                    </a:ext>
                  </a:extLst>
                </a:gridCol>
                <a:gridCol w="572954">
                  <a:extLst>
                    <a:ext uri="{9D8B030D-6E8A-4147-A177-3AD203B41FA5}">
                      <a16:colId xmlns:a16="http://schemas.microsoft.com/office/drawing/2014/main" xmlns="" val="2124266084"/>
                    </a:ext>
                  </a:extLst>
                </a:gridCol>
                <a:gridCol w="3514117">
                  <a:extLst>
                    <a:ext uri="{9D8B030D-6E8A-4147-A177-3AD203B41FA5}">
                      <a16:colId xmlns:a16="http://schemas.microsoft.com/office/drawing/2014/main" xmlns="" val="3088944993"/>
                    </a:ext>
                  </a:extLst>
                </a:gridCol>
                <a:gridCol w="840332">
                  <a:extLst>
                    <a:ext uri="{9D8B030D-6E8A-4147-A177-3AD203B41FA5}">
                      <a16:colId xmlns:a16="http://schemas.microsoft.com/office/drawing/2014/main" xmlns="" val="3147134739"/>
                    </a:ext>
                  </a:extLst>
                </a:gridCol>
                <a:gridCol w="744840">
                  <a:extLst>
                    <a:ext uri="{9D8B030D-6E8A-4147-A177-3AD203B41FA5}">
                      <a16:colId xmlns:a16="http://schemas.microsoft.com/office/drawing/2014/main" xmlns="" val="1750291090"/>
                    </a:ext>
                  </a:extLst>
                </a:gridCol>
                <a:gridCol w="744840">
                  <a:extLst>
                    <a:ext uri="{9D8B030D-6E8A-4147-A177-3AD203B41FA5}">
                      <a16:colId xmlns:a16="http://schemas.microsoft.com/office/drawing/2014/main" xmlns="" val="2735903662"/>
                    </a:ext>
                  </a:extLst>
                </a:gridCol>
                <a:gridCol w="773488">
                  <a:extLst>
                    <a:ext uri="{9D8B030D-6E8A-4147-A177-3AD203B41FA5}">
                      <a16:colId xmlns:a16="http://schemas.microsoft.com/office/drawing/2014/main" xmlns="" val="3842382090"/>
                    </a:ext>
                  </a:extLst>
                </a:gridCol>
              </a:tblGrid>
              <a:tr h="423003"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Plasmid </a:t>
                      </a:r>
                      <a:r>
                        <a:rPr lang="nb-NO" sz="1100" dirty="0" err="1">
                          <a:effectLst/>
                        </a:rPr>
                        <a:t>name</a:t>
                      </a:r>
                      <a:r>
                        <a:rPr lang="nb-NO" sz="1100" dirty="0">
                          <a:effectLst/>
                        </a:rPr>
                        <a:t>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 anchor="b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 err="1">
                          <a:effectLst/>
                        </a:rPr>
                        <a:t>Vector</a:t>
                      </a:r>
                      <a:r>
                        <a:rPr lang="nb-NO" sz="1100" dirty="0">
                          <a:effectLst/>
                        </a:rPr>
                        <a:t> No.</a:t>
                      </a:r>
                      <a:r>
                        <a:rPr lang="nb-NO" sz="900" baseline="30000" dirty="0">
                          <a:effectLst/>
                        </a:rPr>
                        <a:t>1</a:t>
                      </a:r>
                      <a:r>
                        <a:rPr lang="nb-NO" sz="900" dirty="0">
                          <a:effectLst/>
                        </a:rPr>
                        <a:t>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 anchor="b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Relevant </a:t>
                      </a:r>
                      <a:r>
                        <a:rPr lang="nb-NO" sz="1100" dirty="0" err="1">
                          <a:effectLst/>
                        </a:rPr>
                        <a:t>description</a:t>
                      </a:r>
                      <a:r>
                        <a:rPr lang="nb-NO" sz="1100" dirty="0">
                          <a:effectLst/>
                        </a:rPr>
                        <a:t>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 anchor="b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lasmid backbone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 anchor="b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Vector oligos </a:t>
                      </a:r>
                      <a:r>
                        <a:rPr lang="en-US" sz="900" baseline="30000" dirty="0">
                          <a:effectLst/>
                        </a:rPr>
                        <a:t>2</a:t>
                      </a: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 anchor="b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 err="1">
                          <a:effectLst/>
                        </a:rPr>
                        <a:t>Insert</a:t>
                      </a:r>
                      <a:r>
                        <a:rPr lang="nb-NO" sz="1100" dirty="0">
                          <a:effectLst/>
                        </a:rPr>
                        <a:t> </a:t>
                      </a:r>
                      <a:r>
                        <a:rPr lang="nb-NO" sz="1100" dirty="0" err="1">
                          <a:effectLst/>
                        </a:rPr>
                        <a:t>oligos</a:t>
                      </a:r>
                      <a:r>
                        <a:rPr lang="nb-NO" sz="1100" dirty="0">
                          <a:effectLst/>
                        </a:rPr>
                        <a:t> </a:t>
                      </a:r>
                      <a:r>
                        <a:rPr lang="nb-NO" sz="900" baseline="30000" dirty="0">
                          <a:effectLst/>
                        </a:rPr>
                        <a:t>3</a:t>
                      </a:r>
                      <a:r>
                        <a:rPr lang="nb-NO" sz="900" dirty="0">
                          <a:effectLst/>
                        </a:rPr>
                        <a:t>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 anchor="b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Ref. </a:t>
                      </a:r>
                      <a:r>
                        <a:rPr lang="en-US" sz="900" baseline="30000" dirty="0">
                          <a:effectLst/>
                        </a:rPr>
                        <a:t>4</a:t>
                      </a: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 anchor="b"/>
                </a:tc>
                <a:extLst>
                  <a:ext uri="{0D108BD9-81ED-4DB2-BD59-A6C34878D82A}">
                    <a16:rowId xmlns:a16="http://schemas.microsoft.com/office/drawing/2014/main" xmlns="" val="1277838349"/>
                  </a:ext>
                </a:extLst>
              </a:tr>
              <a:tr h="253802"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1100" dirty="0">
                          <a:effectLst/>
                        </a:rPr>
                        <a:t>V1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Carries </a:t>
                      </a:r>
                      <a:r>
                        <a:rPr lang="en-US" sz="1100" dirty="0" err="1">
                          <a:effectLst/>
                        </a:rPr>
                        <a:t>P</a:t>
                      </a:r>
                      <a:r>
                        <a:rPr lang="en-US" sz="900" baseline="-25000" dirty="0" err="1">
                          <a:effectLst/>
                        </a:rPr>
                        <a:t>trc</a:t>
                      </a:r>
                      <a:r>
                        <a:rPr lang="en-US" sz="1100" dirty="0">
                          <a:effectLst/>
                        </a:rPr>
                        <a:t> followed by </a:t>
                      </a:r>
                      <a:r>
                        <a:rPr lang="en-US" sz="1100" dirty="0" err="1">
                          <a:effectLst/>
                        </a:rPr>
                        <a:t>mCherry</a:t>
                      </a:r>
                      <a:r>
                        <a:rPr lang="en-US" sz="1100" dirty="0">
                          <a:effectLst/>
                        </a:rPr>
                        <a:t> gene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1100" b="0" i="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endParaRPr lang="en-US" sz="1100" b="0" i="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endParaRPr lang="en-US" sz="1100" b="0" i="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[39] </a:t>
                      </a:r>
                      <a:endParaRPr lang="en-US" sz="1100" b="0" i="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4601" marR="84601" marT="42300" marB="42300"/>
                </a:tc>
                <a:extLst>
                  <a:ext uri="{0D108BD9-81ED-4DB2-BD59-A6C34878D82A}">
                    <a16:rowId xmlns:a16="http://schemas.microsoft.com/office/drawing/2014/main" xmlns="" val="1461823582"/>
                  </a:ext>
                </a:extLst>
              </a:tr>
              <a:tr h="253802"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NQ705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1100" dirty="0">
                          <a:effectLst/>
                        </a:rPr>
                        <a:t>V2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Suicide vector. Carries </a:t>
                      </a:r>
                      <a:r>
                        <a:rPr lang="en-US" sz="1100" dirty="0" err="1">
                          <a:effectLst/>
                        </a:rPr>
                        <a:t>Cm</a:t>
                      </a:r>
                      <a:r>
                        <a:rPr lang="en-US" sz="900" baseline="30000" dirty="0" err="1">
                          <a:effectLst/>
                        </a:rPr>
                        <a:t>r</a:t>
                      </a:r>
                      <a:r>
                        <a:rPr lang="en-US" sz="1100" dirty="0">
                          <a:effectLst/>
                        </a:rPr>
                        <a:t>, </a:t>
                      </a:r>
                      <a:r>
                        <a:rPr lang="en-US" sz="1100" dirty="0" err="1">
                          <a:effectLst/>
                        </a:rPr>
                        <a:t>pir</a:t>
                      </a:r>
                      <a:r>
                        <a:rPr lang="en-US" sz="1100" dirty="0">
                          <a:effectLst/>
                        </a:rPr>
                        <a:t> for replication. 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endParaRPr lang="en-US" sz="1100" b="0" i="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endParaRPr lang="en-US" sz="1100" b="0" i="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endParaRPr lang="en-US" sz="1100" b="0" i="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[45] </a:t>
                      </a:r>
                      <a:endParaRPr lang="en-US" sz="1100" b="0" i="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4601" marR="84601" marT="42300" marB="42300"/>
                </a:tc>
                <a:extLst>
                  <a:ext uri="{0D108BD9-81ED-4DB2-BD59-A6C34878D82A}">
                    <a16:rowId xmlns:a16="http://schemas.microsoft.com/office/drawing/2014/main" xmlns="" val="850593683"/>
                  </a:ext>
                </a:extLst>
              </a:tr>
              <a:tr h="253802"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VSV208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3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Carries </a:t>
                      </a:r>
                      <a:r>
                        <a:rPr lang="en-US" sz="1100" dirty="0" err="1">
                          <a:effectLst/>
                        </a:rPr>
                        <a:t>Cm</a:t>
                      </a:r>
                      <a:r>
                        <a:rPr lang="en-US" sz="900" baseline="30000" dirty="0" err="1">
                          <a:effectLst/>
                        </a:rPr>
                        <a:t>r</a:t>
                      </a:r>
                      <a:r>
                        <a:rPr lang="en-US" sz="1100" dirty="0">
                          <a:effectLst/>
                        </a:rPr>
                        <a:t>, </a:t>
                      </a:r>
                      <a:r>
                        <a:rPr lang="en-US" sz="1100" dirty="0" err="1">
                          <a:effectLst/>
                        </a:rPr>
                        <a:t>rfp</a:t>
                      </a: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endParaRPr lang="nb-NO" sz="1100" b="0" i="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endParaRPr lang="nb-NO" sz="1100" b="0" i="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endParaRPr lang="nb-NO" sz="1100" b="0" i="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[29] </a:t>
                      </a:r>
                      <a:endParaRPr lang="nb-NO" sz="1100" b="0" i="0" dirty="0"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84601" marR="84601" marT="42300" marB="42300"/>
                </a:tc>
                <a:extLst>
                  <a:ext uri="{0D108BD9-81ED-4DB2-BD59-A6C34878D82A}">
                    <a16:rowId xmlns:a16="http://schemas.microsoft.com/office/drawing/2014/main" xmlns="" val="2943554482"/>
                  </a:ext>
                </a:extLst>
              </a:tr>
              <a:tr h="253802"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_His-GFP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4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 carries N-term His-tag </a:t>
                      </a:r>
                      <a:r>
                        <a:rPr lang="en-US" sz="1100" dirty="0" err="1">
                          <a:effectLst/>
                        </a:rPr>
                        <a:t>gfp</a:t>
                      </a: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5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1+O2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8+O9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This work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extLst>
                  <a:ext uri="{0D108BD9-81ED-4DB2-BD59-A6C34878D82A}">
                    <a16:rowId xmlns:a16="http://schemas.microsoft.com/office/drawing/2014/main" xmlns="" val="3791400075"/>
                  </a:ext>
                </a:extLst>
              </a:tr>
              <a:tr h="423003"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_AsExoI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5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 carries </a:t>
                      </a:r>
                      <a:r>
                        <a:rPr lang="en-US" sz="1100" dirty="0" err="1">
                          <a:effectLst/>
                        </a:rPr>
                        <a:t>ExonucleaseI</a:t>
                      </a:r>
                      <a:r>
                        <a:rPr lang="en-US" sz="1100" dirty="0">
                          <a:effectLst/>
                        </a:rPr>
                        <a:t> gene from </a:t>
                      </a:r>
                      <a:r>
                        <a:rPr lang="en-US" sz="1100" dirty="0" err="1">
                          <a:effectLst/>
                        </a:rPr>
                        <a:t>Aliivibrio</a:t>
                      </a:r>
                      <a:r>
                        <a:rPr lang="en-US" sz="1100" dirty="0">
                          <a:effectLst/>
                        </a:rPr>
                        <a:t> </a:t>
                      </a:r>
                      <a:r>
                        <a:rPr lang="en-US" sz="1100" dirty="0" err="1">
                          <a:effectLst/>
                        </a:rPr>
                        <a:t>salmonicida</a:t>
                      </a: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1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1+O3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4+O5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This work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extLst>
                  <a:ext uri="{0D108BD9-81ED-4DB2-BD59-A6C34878D82A}">
                    <a16:rowId xmlns:a16="http://schemas.microsoft.com/office/drawing/2014/main" xmlns="" val="2334810505"/>
                  </a:ext>
                </a:extLst>
              </a:tr>
              <a:tr h="423003"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_AsPolII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6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 carries DNA </a:t>
                      </a:r>
                      <a:r>
                        <a:rPr lang="en-US" sz="1100" dirty="0" err="1">
                          <a:effectLst/>
                        </a:rPr>
                        <a:t>PolII</a:t>
                      </a:r>
                      <a:r>
                        <a:rPr lang="en-US" sz="1100" dirty="0">
                          <a:effectLst/>
                        </a:rPr>
                        <a:t> gene from </a:t>
                      </a:r>
                      <a:r>
                        <a:rPr lang="en-US" sz="1100" dirty="0" err="1">
                          <a:effectLst/>
                        </a:rPr>
                        <a:t>Aliivibrio</a:t>
                      </a:r>
                      <a:r>
                        <a:rPr lang="en-US" sz="1100" dirty="0">
                          <a:effectLst/>
                        </a:rPr>
                        <a:t> </a:t>
                      </a:r>
                      <a:r>
                        <a:rPr lang="en-US" sz="1100" dirty="0" err="1">
                          <a:effectLst/>
                        </a:rPr>
                        <a:t>salmonicida</a:t>
                      </a: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1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1+O3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6+O7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This work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extLst>
                  <a:ext uri="{0D108BD9-81ED-4DB2-BD59-A6C34878D82A}">
                    <a16:rowId xmlns:a16="http://schemas.microsoft.com/office/drawing/2014/main" xmlns="" val="922320648"/>
                  </a:ext>
                </a:extLst>
              </a:tr>
              <a:tr h="423003"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_P174_GFP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7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 carries 300bp upstream of AW0309160_00174gene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4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10+O11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12+O13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This work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extLst>
                  <a:ext uri="{0D108BD9-81ED-4DB2-BD59-A6C34878D82A}">
                    <a16:rowId xmlns:a16="http://schemas.microsoft.com/office/drawing/2014/main" xmlns="" val="2624320146"/>
                  </a:ext>
                </a:extLst>
              </a:tr>
              <a:tr h="423003"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_5'174GFP-His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8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_174 carries C-term His-tag </a:t>
                      </a:r>
                      <a:r>
                        <a:rPr lang="en-US" sz="1100" dirty="0" err="1">
                          <a:effectLst/>
                        </a:rPr>
                        <a:t>gfp</a:t>
                      </a:r>
                      <a:r>
                        <a:rPr lang="en-US" sz="1100" dirty="0">
                          <a:effectLst/>
                        </a:rPr>
                        <a:t>. 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4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14+O17  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15+O16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This work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extLst>
                  <a:ext uri="{0D108BD9-81ED-4DB2-BD59-A6C34878D82A}">
                    <a16:rowId xmlns:a16="http://schemas.microsoft.com/office/drawing/2014/main" xmlns="" val="2014948580"/>
                  </a:ext>
                </a:extLst>
              </a:tr>
              <a:tr h="423003"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_5'174_ CsLig1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9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_174 carries Ligase1 gene from </a:t>
                      </a:r>
                      <a:r>
                        <a:rPr lang="en-US" sz="1100" dirty="0" err="1">
                          <a:effectLst/>
                        </a:rPr>
                        <a:t>Cenarchaeum</a:t>
                      </a:r>
                      <a:r>
                        <a:rPr lang="en-US" sz="1100" dirty="0">
                          <a:effectLst/>
                        </a:rPr>
                        <a:t> </a:t>
                      </a:r>
                      <a:r>
                        <a:rPr lang="en-US" sz="1100" dirty="0" err="1">
                          <a:effectLst/>
                        </a:rPr>
                        <a:t>symbiosum</a:t>
                      </a: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8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18+O19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28+O29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This work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extLst>
                  <a:ext uri="{0D108BD9-81ED-4DB2-BD59-A6C34878D82A}">
                    <a16:rowId xmlns:a16="http://schemas.microsoft.com/office/drawing/2014/main" xmlns="" val="3297044427"/>
                  </a:ext>
                </a:extLst>
              </a:tr>
              <a:tr h="423003"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_5'174_ CpLig6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10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_174 carries Ligase6 gene from </a:t>
                      </a:r>
                      <a:r>
                        <a:rPr lang="en-US" sz="1100" dirty="0" err="1">
                          <a:effectLst/>
                        </a:rPr>
                        <a:t>Colwellia</a:t>
                      </a:r>
                      <a:r>
                        <a:rPr lang="en-US" sz="1100" dirty="0">
                          <a:effectLst/>
                        </a:rPr>
                        <a:t> </a:t>
                      </a:r>
                      <a:r>
                        <a:rPr lang="en-US" sz="1100" dirty="0" err="1">
                          <a:effectLst/>
                        </a:rPr>
                        <a:t>psychrerythraea</a:t>
                      </a: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8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18+O19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20+O21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This work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extLst>
                  <a:ext uri="{0D108BD9-81ED-4DB2-BD59-A6C34878D82A}">
                    <a16:rowId xmlns:a16="http://schemas.microsoft.com/office/drawing/2014/main" xmlns="" val="2284295061"/>
                  </a:ext>
                </a:extLst>
              </a:tr>
              <a:tr h="423003"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_5'174_ </a:t>
                      </a:r>
                      <a:r>
                        <a:rPr lang="en-US" sz="1100" dirty="0" err="1">
                          <a:effectLst/>
                        </a:rPr>
                        <a:t>MvExoI</a:t>
                      </a: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11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_174 carries </a:t>
                      </a:r>
                      <a:r>
                        <a:rPr lang="en-US" sz="1100" dirty="0" err="1">
                          <a:effectLst/>
                        </a:rPr>
                        <a:t>ExonucleaseI</a:t>
                      </a:r>
                      <a:r>
                        <a:rPr lang="en-US" sz="1100" dirty="0">
                          <a:effectLst/>
                        </a:rPr>
                        <a:t> gene from </a:t>
                      </a:r>
                      <a:r>
                        <a:rPr lang="en-US" sz="1100" dirty="0" err="1">
                          <a:effectLst/>
                        </a:rPr>
                        <a:t>Moritella</a:t>
                      </a:r>
                      <a:r>
                        <a:rPr lang="en-US" sz="1100" dirty="0">
                          <a:effectLst/>
                        </a:rPr>
                        <a:t> </a:t>
                      </a:r>
                      <a:r>
                        <a:rPr lang="en-US" sz="1100" dirty="0" err="1">
                          <a:effectLst/>
                        </a:rPr>
                        <a:t>viscosa</a:t>
                      </a: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8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18+O19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24+O25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This work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extLst>
                  <a:ext uri="{0D108BD9-81ED-4DB2-BD59-A6C34878D82A}">
                    <a16:rowId xmlns:a16="http://schemas.microsoft.com/office/drawing/2014/main" xmlns="" val="2218874415"/>
                  </a:ext>
                </a:extLst>
              </a:tr>
              <a:tr h="423003"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_5'174_ </a:t>
                      </a:r>
                      <a:r>
                        <a:rPr lang="en-US" sz="1100" dirty="0" err="1">
                          <a:effectLst/>
                        </a:rPr>
                        <a:t>AdhStrep</a:t>
                      </a: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12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_174 carries </a:t>
                      </a:r>
                      <a:r>
                        <a:rPr lang="en-US" sz="1100" dirty="0" err="1">
                          <a:effectLst/>
                        </a:rPr>
                        <a:t>alkoholdehydrogenase</a:t>
                      </a:r>
                      <a:r>
                        <a:rPr lang="en-US" sz="1100" dirty="0">
                          <a:effectLst/>
                        </a:rPr>
                        <a:t> from Streptomyces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8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18+O19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O26+O27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This work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extLst>
                  <a:ext uri="{0D108BD9-81ED-4DB2-BD59-A6C34878D82A}">
                    <a16:rowId xmlns:a16="http://schemas.microsoft.com/office/drawing/2014/main" xmlns="" val="2550000868"/>
                  </a:ext>
                </a:extLst>
              </a:tr>
              <a:tr h="930607">
                <a:tc>
                  <a:txBody>
                    <a:bodyPr/>
                    <a:lstStyle/>
                    <a:p>
                      <a:pPr algn="l" rtl="0" fontAlgn="base"/>
                      <a:r>
                        <a:rPr lang="nb-NO" sz="1100" dirty="0" smtClean="0">
                          <a:effectLst/>
                        </a:rPr>
                        <a:t>pTM214_sfGFP</a:t>
                      </a:r>
                      <a:r>
                        <a:rPr lang="nb-NO" sz="1100" dirty="0">
                          <a:effectLst/>
                        </a:rPr>
                        <a:t> </a:t>
                      </a:r>
                      <a:endParaRPr lang="nb-NO" sz="1700" dirty="0">
                        <a:effectLst/>
                      </a:endParaRPr>
                    </a:p>
                    <a:p>
                      <a:pPr algn="l" rtl="0" fontAlgn="base"/>
                      <a:r>
                        <a:rPr lang="nb-NO" sz="1100" dirty="0">
                          <a:effectLst/>
                        </a:rPr>
                        <a:t>pTM214_174ss_sfGFP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nb-NO" sz="1100" dirty="0">
                          <a:effectLst/>
                        </a:rPr>
                        <a:t>V13 </a:t>
                      </a:r>
                      <a:endParaRPr lang="nb-NO" sz="1700" dirty="0">
                        <a:effectLst/>
                      </a:endParaRPr>
                    </a:p>
                    <a:p>
                      <a:pPr algn="ctr" rtl="0" fontAlgn="base"/>
                      <a:r>
                        <a:rPr lang="nb-NO" sz="1100" dirty="0" smtClean="0">
                          <a:effectLst/>
                        </a:rPr>
                        <a:t>V14</a:t>
                      </a:r>
                      <a:r>
                        <a:rPr lang="nb-NO" sz="1100" dirty="0">
                          <a:effectLst/>
                        </a:rPr>
                        <a:t> </a:t>
                      </a:r>
                      <a:endParaRPr lang="nb-NO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 smtClean="0">
                          <a:effectLst/>
                        </a:rPr>
                        <a:t>pTM214 </a:t>
                      </a:r>
                      <a:r>
                        <a:rPr lang="en-US" sz="1100" dirty="0">
                          <a:effectLst/>
                        </a:rPr>
                        <a:t>carries C-term His-tag </a:t>
                      </a:r>
                      <a:r>
                        <a:rPr lang="en-US" sz="1100" dirty="0" err="1">
                          <a:effectLst/>
                        </a:rPr>
                        <a:t>sfgfp</a:t>
                      </a: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700" dirty="0">
                        <a:effectLst/>
                      </a:endParaRPr>
                    </a:p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pTM214 carries N-terminal signal sequence 174 C-term His-tag </a:t>
                      </a:r>
                      <a:r>
                        <a:rPr lang="en-US" sz="1100" dirty="0" err="1">
                          <a:effectLst/>
                        </a:rPr>
                        <a:t>sfgfp</a:t>
                      </a: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ctr" rtl="0" fontAlgn="base"/>
                      <a:r>
                        <a:rPr lang="en-US" sz="1100" dirty="0" smtClean="0">
                          <a:effectLst/>
                        </a:rPr>
                        <a:t>V8</a:t>
                      </a: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700" dirty="0">
                        <a:effectLst/>
                      </a:endParaRPr>
                    </a:p>
                    <a:p>
                      <a:pPr algn="ctr" rtl="0" fontAlgn="base"/>
                      <a:r>
                        <a:rPr lang="en-US" sz="1100" dirty="0">
                          <a:effectLst/>
                        </a:rPr>
                        <a:t>V8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 smtClean="0">
                          <a:effectLst/>
                        </a:rPr>
                        <a:t>O3+O19</a:t>
                      </a: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700" dirty="0">
                        <a:effectLst/>
                      </a:endParaRPr>
                    </a:p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O32+O3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 smtClean="0">
                          <a:effectLst/>
                        </a:rPr>
                        <a:t>O33+O34</a:t>
                      </a: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700" dirty="0">
                        <a:effectLst/>
                      </a:endParaRPr>
                    </a:p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O30+O31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tc>
                  <a:txBody>
                    <a:bodyPr/>
                    <a:lstStyle/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This work </a:t>
                      </a:r>
                      <a:endParaRPr lang="en-US" sz="1700" dirty="0">
                        <a:effectLst/>
                      </a:endParaRPr>
                    </a:p>
                    <a:p>
                      <a:pPr algn="l" rtl="0" fontAlgn="base"/>
                      <a:r>
                        <a:rPr lang="en-US" sz="1100" dirty="0">
                          <a:effectLst/>
                        </a:rPr>
                        <a:t>This </a:t>
                      </a:r>
                      <a:r>
                        <a:rPr lang="en-US" sz="1100" dirty="0" smtClean="0">
                          <a:effectLst/>
                        </a:rPr>
                        <a:t>work</a:t>
                      </a: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700" b="0" i="0" dirty="0">
                        <a:effectLst/>
                      </a:endParaRPr>
                    </a:p>
                  </a:txBody>
                  <a:tcPr marL="84601" marR="84601" marT="42300" marB="42300"/>
                </a:tc>
                <a:extLst>
                  <a:ext uri="{0D108BD9-81ED-4DB2-BD59-A6C34878D82A}">
                    <a16:rowId xmlns:a16="http://schemas.microsoft.com/office/drawing/2014/main" xmlns="" val="1328285302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FAE66DE7-3908-406E-A1AF-03E3871A5459}"/>
              </a:ext>
            </a:extLst>
          </p:cNvPr>
          <p:cNvSpPr txBox="1"/>
          <p:nvPr/>
        </p:nvSpPr>
        <p:spPr>
          <a:xfrm>
            <a:off x="2494027" y="5952253"/>
            <a:ext cx="8836290" cy="830997"/>
          </a:xfrm>
          <a:prstGeom prst="rect">
            <a:avLst/>
          </a:prstGeom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>
            <a:defPPr>
              <a:defRPr lang="nb-NO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50" baseline="30000" dirty="0">
                <a:latin typeface="Times New Roman"/>
                <a:cs typeface="Times New Roman"/>
              </a:rPr>
              <a:t>1</a:t>
            </a:r>
            <a:r>
              <a:rPr lang="en-US" sz="1200" dirty="0">
                <a:latin typeface="Times New Roman"/>
                <a:cs typeface="Times New Roman"/>
              </a:rPr>
              <a:t> Vector number. </a:t>
            </a:r>
          </a:p>
          <a:p>
            <a:r>
              <a:rPr lang="en-US" sz="950" baseline="30000" dirty="0">
                <a:latin typeface="Times New Roman"/>
                <a:cs typeface="Times New Roman"/>
              </a:rPr>
              <a:t>2</a:t>
            </a:r>
            <a:r>
              <a:rPr lang="en-US" sz="1200" dirty="0">
                <a:latin typeface="Times New Roman"/>
                <a:cs typeface="Times New Roman"/>
              </a:rPr>
              <a:t> Oligonucleotides used for amplification of vector backbone during Fast cloning. Oligonucleotides are listed in </a:t>
            </a:r>
            <a:r>
              <a:rPr lang="en-US" sz="1200" b="1" dirty="0">
                <a:latin typeface="Times New Roman"/>
                <a:cs typeface="Times New Roman"/>
              </a:rPr>
              <a:t>Table S1</a:t>
            </a:r>
            <a:r>
              <a:rPr lang="en-US" sz="1200" dirty="0">
                <a:latin typeface="Times New Roman"/>
                <a:cs typeface="Times New Roman"/>
              </a:rPr>
              <a:t>. </a:t>
            </a:r>
          </a:p>
          <a:p>
            <a:r>
              <a:rPr lang="en-US" sz="950" baseline="30000" dirty="0">
                <a:latin typeface="Times New Roman"/>
                <a:cs typeface="Times New Roman"/>
              </a:rPr>
              <a:t>3</a:t>
            </a:r>
            <a:r>
              <a:rPr lang="en-US" sz="1200" dirty="0">
                <a:latin typeface="Times New Roman"/>
                <a:cs typeface="Times New Roman"/>
              </a:rPr>
              <a:t> Oligonucleotides used for amplification of insert (target gene) during Fast cloning. Oligonucleotides are listed in </a:t>
            </a:r>
            <a:r>
              <a:rPr lang="en-US" sz="1200" b="1" dirty="0">
                <a:latin typeface="Times New Roman"/>
                <a:cs typeface="Times New Roman"/>
              </a:rPr>
              <a:t>Table S1.</a:t>
            </a:r>
            <a:r>
              <a:rPr lang="en-US" sz="1200" dirty="0">
                <a:latin typeface="Times New Roman"/>
                <a:cs typeface="Times New Roman"/>
              </a:rPr>
              <a:t> </a:t>
            </a:r>
          </a:p>
          <a:p>
            <a:r>
              <a:rPr lang="en-US" sz="950" baseline="30000" dirty="0">
                <a:latin typeface="Times New Roman"/>
                <a:cs typeface="Times New Roman"/>
              </a:rPr>
              <a:t>4</a:t>
            </a:r>
            <a:r>
              <a:rPr lang="en-US" sz="1200" dirty="0">
                <a:latin typeface="Times New Roman"/>
                <a:cs typeface="Times New Roman"/>
              </a:rPr>
              <a:t> References. [39] Miyashiro et al. 2011, [45] Milton et al. 1992, [29] Dunn et al. 2006. </a:t>
            </a:r>
          </a:p>
        </p:txBody>
      </p:sp>
    </p:spTree>
    <p:extLst>
      <p:ext uri="{BB962C8B-B14F-4D97-AF65-F5344CB8AC3E}">
        <p14:creationId xmlns:p14="http://schemas.microsoft.com/office/powerpoint/2010/main" xmlns="" val="31100052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363</Words>
  <Application>Microsoft Office PowerPoint</Application>
  <PresentationFormat>Custom</PresentationFormat>
  <Paragraphs>221</Paragraphs>
  <Slides>3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lide 1</vt:lpstr>
      <vt:lpstr>Slide 2</vt:lpstr>
      <vt:lpstr>Slide 3</vt:lpstr>
    </vt:vector>
  </TitlesOfParts>
  <Company>UiT Norges arktiske universite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ik Haugen</dc:creator>
  <cp:lastModifiedBy>0011692</cp:lastModifiedBy>
  <cp:revision>55</cp:revision>
  <dcterms:created xsi:type="dcterms:W3CDTF">2019-01-04T09:06:53Z</dcterms:created>
  <dcterms:modified xsi:type="dcterms:W3CDTF">2019-11-02T03:55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ed372810-6bc5-4b24-a067-8742f322c238_Enabled">
    <vt:lpwstr>True</vt:lpwstr>
  </property>
  <property fmtid="{D5CDD505-2E9C-101B-9397-08002B2CF9AE}" pid="3" name="MSIP_Label_ed372810-6bc5-4b24-a067-8742f322c238_SiteId">
    <vt:lpwstr>4e7f212d-74db-4563-a57b-8ae44ed05526</vt:lpwstr>
  </property>
  <property fmtid="{D5CDD505-2E9C-101B-9397-08002B2CF9AE}" pid="4" name="MSIP_Label_ed372810-6bc5-4b24-a067-8742f322c238_Owner">
    <vt:lpwstr>pha001@uit.no</vt:lpwstr>
  </property>
  <property fmtid="{D5CDD505-2E9C-101B-9397-08002B2CF9AE}" pid="5" name="MSIP_Label_ed372810-6bc5-4b24-a067-8742f322c238_SetDate">
    <vt:lpwstr>2019-01-04T09:11:17.9011085Z</vt:lpwstr>
  </property>
  <property fmtid="{D5CDD505-2E9C-101B-9397-08002B2CF9AE}" pid="6" name="MSIP_Label_ed372810-6bc5-4b24-a067-8742f322c238_Name">
    <vt:lpwstr>Open</vt:lpwstr>
  </property>
  <property fmtid="{D5CDD505-2E9C-101B-9397-08002B2CF9AE}" pid="7" name="MSIP_Label_ed372810-6bc5-4b24-a067-8742f322c238_Application">
    <vt:lpwstr>Microsoft Azure Information Protection</vt:lpwstr>
  </property>
  <property fmtid="{D5CDD505-2E9C-101B-9397-08002B2CF9AE}" pid="8" name="MSIP_Label_ed372810-6bc5-4b24-a067-8742f322c238_Extended_MSFT_Method">
    <vt:lpwstr>Manual</vt:lpwstr>
  </property>
  <property fmtid="{D5CDD505-2E9C-101B-9397-08002B2CF9AE}" pid="9" name="Sensitivity">
    <vt:lpwstr>Open</vt:lpwstr>
  </property>
</Properties>
</file>